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59"/>
    <p:restoredTop sz="94676"/>
  </p:normalViewPr>
  <p:slideViewPr>
    <p:cSldViewPr snapToGrid="0">
      <p:cViewPr varScale="1">
        <p:scale>
          <a:sx n="114" d="100"/>
          <a:sy n="114" d="100"/>
        </p:scale>
        <p:origin x="5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403308-D903-3591-44B7-954ED9ACF4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24B4B1D-5B89-75CD-FAEB-A078557724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FE1B86-9A86-C8DF-5BB3-C913ED9A3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6EDC56-36CC-8502-EEA3-96BD0DF43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2625F78-911B-B442-DED8-0DD34CC54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0466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DD898C-CF8A-6929-5C56-7F9AD06758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1BA2AE-8A03-05B8-8EDA-9334108AC1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0C1B08-5BB2-0CA6-28D6-69BE890B7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681ACF-0441-3A04-097F-5E39C9E3D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14508D-B8D1-8F30-7953-10563915C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4658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C8AC83C-E258-5AAB-B3E2-F5396624D3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74CDDBA-D910-5B07-8F22-6A5425E6E0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2321E0-C17F-5BA6-02DA-5E26685C4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96ECE2-97FF-8949-B766-5A43ECB15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D63EA7-FAC7-BBCB-8143-18035F388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58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CB710A-C88F-90BF-C578-552D710B71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8CB131-B2DF-7B36-D1AE-C3CDB6D98B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91FDA9-659E-796C-4037-57808FCFF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9D8955-B411-1B10-0995-7B66D00B1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4EBB758-C815-8213-CB93-FEBFA4B9C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981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DB51C4-1332-0E28-7FB9-6A0806E3F9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9E540B-71BC-AD35-139A-333349F525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A0F124-E827-E110-8D68-8CA13EF80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7FD352-0107-1BAC-D9C1-AEEE7C7CD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5B4A87-A501-0758-C03C-2DF98C833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9225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D9AE04-3A6D-9B7B-F42D-EF01077224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9DE8072-40CE-C9D8-6226-DAC2816173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2047EEF-BD6C-06A0-EB32-7A19C3D0A4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463F29F-0C28-FBCF-BC6B-093DD9A91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4BCD831-5527-72D8-EA10-99663C4C4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21DF887-702C-0289-EC0B-83A0824FD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17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880499-A807-19F1-352E-23D21B73F1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73D6EF-5B43-9897-4CD3-53D80D78A4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9464FCC-BCF7-B336-238A-15567CD602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0010EFD-4795-CA71-A1DB-C60E1B787F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F7C8605-EF2A-B29A-9411-1E0C3A5871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CEBF761-88FB-651A-22D6-4C6B18A69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5E033B9-3EEF-D611-7333-EF9E7AD69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AC7A16B-997F-C893-504E-1F5B5D7EE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2356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49F111-7B81-1A92-CC0D-12581AC849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912745D-649E-77D0-0CA3-B03EFF18B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E78B773-CAF4-FE73-EA14-1119FD260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8437C93-5F38-2411-6033-BAEF6808A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20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F1A7075-F58E-6731-1D87-395DA7662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ED6E775-2031-A12B-8570-8379B4861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9A5E599-6133-4E1E-960B-53313E95D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901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AF476B-22BC-EB7D-BA77-09DA7656B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2C3A694-039B-7A17-9B72-64EB18405B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3B41B0E-0818-75E4-E95B-BDC58AFAF8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F94C6D3-9157-ABCA-FCA1-2F55F57FB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ED526E-97D1-D358-5AA6-B82AE209F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94DB56-A0A2-CE46-8B97-2E2E5E663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924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F23159-2CCB-EADB-E5C4-05F65B742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27C2BEE-FC7C-36CA-37C5-CE61EA86B0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2F890AA-AA90-9306-5319-C7EC2BA409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3E6AF6A-B70D-B53B-993E-758A32927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CA126D0-E6F7-6504-779D-CF38A1CBC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737872-7B8D-2B07-C3AB-61E70F2A3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735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45CCECF-BC4F-36A0-2992-DFFC63267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F4D33B1-174B-1A78-71F3-8D2410E70C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040F346-5179-6DCB-845D-6F4C861DA6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7B7E1-801D-7C4E-85B4-E6073BC5A38A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96DADD-63B0-3117-1680-F83B7B71DA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CF6D9E-6208-6DC2-D881-658C7ABE72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5A7946-279A-F04C-B663-9240BF5C6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535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7845232-C421-93F0-95BE-B3226A29F6BC}"/>
              </a:ext>
            </a:extLst>
          </p:cNvPr>
          <p:cNvSpPr/>
          <p:nvPr/>
        </p:nvSpPr>
        <p:spPr>
          <a:xfrm>
            <a:off x="2351894" y="428478"/>
            <a:ext cx="4963307" cy="634268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</a:rPr>
              <a:t>184 patients were assessed for eligibility</a:t>
            </a:r>
            <a:endParaRPr kumimoji="1" lang="ja-JP" altLang="en-US" sz="1100">
              <a:solidFill>
                <a:schemeClr val="tx1"/>
              </a:solidFill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5C79240-5ED8-346F-31A4-5673424970B1}"/>
              </a:ext>
            </a:extLst>
          </p:cNvPr>
          <p:cNvSpPr/>
          <p:nvPr/>
        </p:nvSpPr>
        <p:spPr>
          <a:xfrm>
            <a:off x="5608725" y="1562017"/>
            <a:ext cx="3499456" cy="12715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100" dirty="0">
                <a:solidFill>
                  <a:schemeClr val="tx1"/>
                </a:solidFill>
              </a:rPr>
              <a:t>60 </a:t>
            </a:r>
            <a:r>
              <a:rPr kumimoji="1" lang="en-US" altLang="ja-JP" sz="1100" dirty="0">
                <a:solidFill>
                  <a:schemeClr val="tx1"/>
                </a:solidFill>
              </a:rPr>
              <a:t>patients were not enrolled</a:t>
            </a:r>
          </a:p>
          <a:p>
            <a:r>
              <a:rPr lang="en-US" altLang="ja-JP" sz="1100" dirty="0">
                <a:solidFill>
                  <a:schemeClr val="tx1"/>
                </a:solidFill>
              </a:rPr>
              <a:t>     - 47 Did not received treatment for first-line</a:t>
            </a:r>
          </a:p>
          <a:p>
            <a:r>
              <a:rPr kumimoji="1" lang="en-US" altLang="ja-JP" sz="1100" dirty="0">
                <a:solidFill>
                  <a:schemeClr val="tx1"/>
                </a:solidFill>
              </a:rPr>
              <a:t>     - 4 Diagnosed with </a:t>
            </a:r>
            <a:r>
              <a:rPr lang="en-US" altLang="ja-JP" sz="1100" dirty="0">
                <a:solidFill>
                  <a:schemeClr val="tx1"/>
                </a:solidFill>
              </a:rPr>
              <a:t>LCNEC</a:t>
            </a:r>
          </a:p>
          <a:p>
            <a:r>
              <a:rPr kumimoji="1" lang="en-US" altLang="ja-JP" sz="1100" dirty="0">
                <a:solidFill>
                  <a:schemeClr val="tx1"/>
                </a:solidFill>
              </a:rPr>
              <a:t>     - 9 Systemic corticosteroid use</a:t>
            </a:r>
            <a:endParaRPr kumimoji="1" lang="ja-JP" altLang="en-US" sz="1100">
              <a:solidFill>
                <a:schemeClr val="tx1"/>
              </a:solidFill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F155D0A0-A735-8DD2-78D2-BC2A1CB9D06F}"/>
              </a:ext>
            </a:extLst>
          </p:cNvPr>
          <p:cNvCxnSpPr>
            <a:cxnSpLocks/>
            <a:stCxn id="2" idx="2"/>
            <a:endCxn id="10" idx="0"/>
          </p:cNvCxnSpPr>
          <p:nvPr/>
        </p:nvCxnSpPr>
        <p:spPr>
          <a:xfrm>
            <a:off x="4833548" y="1062746"/>
            <a:ext cx="0" cy="2262852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3BAAAD9C-A251-D7B5-13DB-C9A4A76190E6}"/>
              </a:ext>
            </a:extLst>
          </p:cNvPr>
          <p:cNvCxnSpPr>
            <a:cxnSpLocks/>
            <a:endCxn id="3" idx="1"/>
          </p:cNvCxnSpPr>
          <p:nvPr/>
        </p:nvCxnSpPr>
        <p:spPr>
          <a:xfrm>
            <a:off x="4831518" y="2197806"/>
            <a:ext cx="777207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E40C3E16-418C-3461-BCE7-01988665670B}"/>
              </a:ext>
            </a:extLst>
          </p:cNvPr>
          <p:cNvSpPr/>
          <p:nvPr/>
        </p:nvSpPr>
        <p:spPr>
          <a:xfrm>
            <a:off x="2351894" y="3325598"/>
            <a:ext cx="4963307" cy="634268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100" dirty="0">
                <a:solidFill>
                  <a:schemeClr val="tx1"/>
                </a:solidFill>
              </a:rPr>
              <a:t>124 patients were enrolled in the study</a:t>
            </a:r>
            <a:endParaRPr kumimoji="1" lang="ja-JP" altLang="en-US" sz="1100">
              <a:solidFill>
                <a:schemeClr val="tx1"/>
              </a:solidFill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A6B9FF2-7C6D-8472-8654-7BC68786D887}"/>
              </a:ext>
            </a:extLst>
          </p:cNvPr>
          <p:cNvSpPr txBox="1"/>
          <p:nvPr/>
        </p:nvSpPr>
        <p:spPr>
          <a:xfrm>
            <a:off x="2351894" y="6535458"/>
            <a:ext cx="19928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Figure S1. Consort diagram</a:t>
            </a:r>
            <a:r>
              <a:rPr lang="ja-JP" altLang="ja-JP" sz="1100"/>
              <a:t> </a:t>
            </a:r>
            <a:endParaRPr kumimoji="1" lang="ja-JP" altLang="en-US" sz="110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BC39A242-E8C2-2A6D-CC7C-345C57569182}"/>
              </a:ext>
            </a:extLst>
          </p:cNvPr>
          <p:cNvSpPr/>
          <p:nvPr/>
        </p:nvSpPr>
        <p:spPr>
          <a:xfrm>
            <a:off x="2351893" y="5087658"/>
            <a:ext cx="4963307" cy="8135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100" b="0" i="0" u="none" strike="noStrike" dirty="0">
                <a:solidFill>
                  <a:schemeClr val="tx1"/>
                </a:solidFill>
                <a:effectLst/>
                <a:latin typeface="+mn-ea"/>
              </a:rPr>
              <a:t>124 patients were included in the final analysis, </a:t>
            </a:r>
          </a:p>
          <a:p>
            <a:pPr algn="ctr"/>
            <a:r>
              <a:rPr lang="en-US" altLang="ja-JP" sz="1100" b="0" i="0" u="none" strike="noStrike" dirty="0">
                <a:solidFill>
                  <a:schemeClr val="tx1"/>
                </a:solidFill>
                <a:effectLst/>
                <a:latin typeface="+mn-ea"/>
              </a:rPr>
              <a:t>except for the multivariate analyses, in which 7 patients with unknown PD-L1 expression were excluded.</a:t>
            </a:r>
            <a:endParaRPr kumimoji="1" lang="ja-JP" altLang="en-US" sz="1100">
              <a:solidFill>
                <a:schemeClr val="tx1"/>
              </a:solidFill>
              <a:latin typeface="+mn-ea"/>
            </a:endParaRP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54D42FE0-98BC-AAAF-9013-B2B44CC39FAE}"/>
              </a:ext>
            </a:extLst>
          </p:cNvPr>
          <p:cNvCxnSpPr>
            <a:cxnSpLocks/>
            <a:stCxn id="10" idx="2"/>
            <a:endCxn id="9" idx="0"/>
          </p:cNvCxnSpPr>
          <p:nvPr/>
        </p:nvCxnSpPr>
        <p:spPr>
          <a:xfrm flipH="1">
            <a:off x="4833547" y="3959866"/>
            <a:ext cx="1" cy="1127792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D5D5D93-1A50-74F9-7DBF-EBB495976E2F}"/>
              </a:ext>
            </a:extLst>
          </p:cNvPr>
          <p:cNvSpPr txBox="1"/>
          <p:nvPr/>
        </p:nvSpPr>
        <p:spPr>
          <a:xfrm>
            <a:off x="4833547" y="1096199"/>
            <a:ext cx="6734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0" i="0" u="none" strike="noStrike" dirty="0">
                <a:effectLst/>
                <a:latin typeface="+mn-ea"/>
              </a:rPr>
              <a:t>Eligible patients were those with advanced or recurrent NSCLC who received first-line ICI-based therapy.</a:t>
            </a:r>
            <a:endParaRPr kumimoji="1" lang="ja-JP" altLang="en-US" sz="1050">
              <a:latin typeface="+mn-ea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7F657EF-0E44-10B5-155C-AAFAE8E808FB}"/>
              </a:ext>
            </a:extLst>
          </p:cNvPr>
          <p:cNvSpPr txBox="1"/>
          <p:nvPr/>
        </p:nvSpPr>
        <p:spPr>
          <a:xfrm>
            <a:off x="4833547" y="3981777"/>
            <a:ext cx="6099586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50" b="0" i="0" u="none" strike="noStrike" dirty="0">
                <a:effectLst/>
                <a:latin typeface="+mn-ea"/>
              </a:rPr>
              <a:t>All patients were followed until progression or death.</a:t>
            </a:r>
            <a:endParaRPr lang="ja-JP" altLang="en-US" sz="1050"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1586637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94</Words>
  <Application>Microsoft Macintosh PowerPoint</Application>
  <PresentationFormat>ワイド画面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saiki</dc:creator>
  <cp:lastModifiedBy>msaiki</cp:lastModifiedBy>
  <cp:revision>6</cp:revision>
  <dcterms:created xsi:type="dcterms:W3CDTF">2025-05-22T14:23:49Z</dcterms:created>
  <dcterms:modified xsi:type="dcterms:W3CDTF">2025-10-15T11:43:42Z</dcterms:modified>
</cp:coreProperties>
</file>